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9.jpeg" ContentType="image/jpeg"/>
  <Override PartName="/ppt/media/image11.jpeg" ContentType="image/jpeg"/>
  <Override PartName="/ppt/media/image15.jpeg" ContentType="image/jpeg"/>
  <Override PartName="/ppt/media/image14.jpeg" ContentType="image/jpeg"/>
  <Override PartName="/ppt/media/image1.jpeg" ContentType="image/jpeg"/>
  <Override PartName="/ppt/media/image2.jpeg" ContentType="image/jpeg"/>
  <Override PartName="/ppt/media/image3.jpeg" ContentType="image/jpeg"/>
  <Override PartName="/ppt/media/image4.jpeg" ContentType="image/jpeg"/>
  <Override PartName="/ppt/media/image5.jpeg" ContentType="image/jpeg"/>
  <Override PartName="/ppt/media/image6.jpeg" ContentType="image/jpeg"/>
  <Override PartName="/ppt/media/image7.jpeg" ContentType="image/jpeg"/>
  <Override PartName="/ppt/media/image12.jpeg" ContentType="image/jpeg"/>
  <Override PartName="/ppt/media/image10.jpeg" ContentType="image/jpeg"/>
  <Override PartName="/ppt/media/image8.jpeg" ContentType="image/jpeg"/>
  <Override PartName="/ppt/media/image13.jpeg" ContentType="image/jpeg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DA1EF6D-FC59-4578-9C1F-CD8E74185944}" type="datetime">
              <a:rPr b="0" lang="de-DE" sz="1200" spc="-1" strike="noStrike">
                <a:solidFill>
                  <a:srgbClr val="000000"/>
                </a:solidFill>
                <a:latin typeface="Calibri"/>
              </a:rPr>
              <a:t>29.08.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1143000" y="685440"/>
            <a:ext cx="4572000" cy="342900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8E146F6-4355-4D24-89EB-4D3E2A010A5E}" type="slidenum">
              <a:rPr b="0" lang="en-GB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PlaceHolder 1"/>
          <p:cNvSpPr>
            <a:spLocks noGrp="1"/>
          </p:cNvSpPr>
          <p:nvPr>
            <p:ph type="sldImg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ln w="0">
            <a:noFill/>
          </a:ln>
        </p:spPr>
      </p:sp>
      <p:sp>
        <p:nvSpPr>
          <p:cNvPr id="68" name="PlaceHolder 2"/>
          <p:cNvSpPr>
            <a:spLocks noGrp="1"/>
          </p:cNvSpPr>
          <p:nvPr>
            <p:ph type="body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GB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9" name="Foliennummernplatzhalter 3"/>
          <p:cNvSpPr/>
          <p:nvPr/>
        </p:nvSpPr>
        <p:spPr>
          <a:xfrm>
            <a:off x="3884760" y="8685360"/>
            <a:ext cx="2971800" cy="4572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AF99E56-554F-45FF-8A65-D9463161971D}" type="slidenum">
              <a:rPr b="0" lang="en-GB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5F25D29-50FE-4CA4-925E-B2419A5B024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228449A-8D27-4CB9-B146-B68B82401EE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507DA4-0E0C-4E15-A91C-C634115BFD2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34B638C-4023-4101-B9AE-DADE89A65FA9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03FCF1C-7936-4BEA-90D6-A3DBD2BF70C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860B5CB-D301-4188-97C0-742F21EC3822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9B5304-19A9-43C7-B979-03FDCA81028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33F655A-7622-4368-B82F-23C45C8FACB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05362E8-4088-4AF3-90D2-3BBF63C15BD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AB46C7D-45B2-4ECC-959A-825CFF7495C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38918FC-ABB9-4E57-BEC7-0AE33CE2A02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B994A7-2E87-4304-8D4E-95A9CB583FA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F7D9BE8-29A4-4BC2-9BC6-EE1ACE4E5FE0}" type="datetime">
              <a:rPr b="0" lang="de-DE" sz="1200" spc="-1" strike="noStrike">
                <a:solidFill>
                  <a:srgbClr val="898989"/>
                </a:solidFill>
                <a:latin typeface="Calibri"/>
              </a:rPr>
              <a:t>29.08.26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25B81DCA-EEA1-476D-8786-33A4EDC18D5E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image" Target="../media/image3.jpeg"/><Relationship Id="rId4" Type="http://schemas.openxmlformats.org/officeDocument/2006/relationships/image" Target="../media/image4.jpeg"/><Relationship Id="rId5" Type="http://schemas.openxmlformats.org/officeDocument/2006/relationships/image" Target="../media/image5.jpeg"/><Relationship Id="rId6" Type="http://schemas.openxmlformats.org/officeDocument/2006/relationships/image" Target="../media/image6.jpeg"/><Relationship Id="rId7" Type="http://schemas.openxmlformats.org/officeDocument/2006/relationships/image" Target="../media/image7.jpeg"/><Relationship Id="rId8" Type="http://schemas.openxmlformats.org/officeDocument/2006/relationships/image" Target="../media/image8.jpeg"/><Relationship Id="rId9" Type="http://schemas.openxmlformats.org/officeDocument/2006/relationships/image" Target="../media/image9.jpeg"/><Relationship Id="rId10" Type="http://schemas.openxmlformats.org/officeDocument/2006/relationships/image" Target="../media/image10.jpeg"/><Relationship Id="rId11" Type="http://schemas.openxmlformats.org/officeDocument/2006/relationships/image" Target="../media/image11.jpeg"/><Relationship Id="rId12" Type="http://schemas.openxmlformats.org/officeDocument/2006/relationships/image" Target="../media/image12.jpeg"/><Relationship Id="rId13" Type="http://schemas.openxmlformats.org/officeDocument/2006/relationships/image" Target="../media/image13.jpeg"/><Relationship Id="rId14" Type="http://schemas.openxmlformats.org/officeDocument/2006/relationships/image" Target="../media/image14.jpeg"/><Relationship Id="rId15" Type="http://schemas.openxmlformats.org/officeDocument/2006/relationships/image" Target="../media/image15.jpeg"/><Relationship Id="rId16" Type="http://schemas.openxmlformats.org/officeDocument/2006/relationships/slideLayout" Target="../slideLayouts/slideLayout1.xml"/><Relationship Id="rId17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Gruppieren 21"/>
          <p:cNvGrpSpPr/>
          <p:nvPr/>
        </p:nvGrpSpPr>
        <p:grpSpPr>
          <a:xfrm>
            <a:off x="174600" y="0"/>
            <a:ext cx="8745480" cy="5221440"/>
            <a:chOff x="174600" y="0"/>
            <a:chExt cx="8745480" cy="5221440"/>
          </a:xfrm>
        </p:grpSpPr>
        <p:pic>
          <p:nvPicPr>
            <p:cNvPr id="49" name="Grafik 3" descr="EYFP blau.jpg"/>
            <p:cNvPicPr/>
            <p:nvPr/>
          </p:nvPicPr>
          <p:blipFill>
            <a:blip r:embed="rId1"/>
            <a:stretch/>
          </p:blipFill>
          <p:spPr>
            <a:xfrm>
              <a:off x="7263360" y="587880"/>
              <a:ext cx="1439640" cy="1508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0" name="Grafik 4" descr="EYFP blau grün rot#.jpg"/>
            <p:cNvPicPr/>
            <p:nvPr/>
          </p:nvPicPr>
          <p:blipFill>
            <a:blip r:embed="rId2"/>
            <a:stretch/>
          </p:blipFill>
          <p:spPr>
            <a:xfrm>
              <a:off x="1221120" y="587880"/>
              <a:ext cx="1439640" cy="1508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1" name="Grafik 5" descr="EYFP blau rot.jpg"/>
            <p:cNvPicPr/>
            <p:nvPr/>
          </p:nvPicPr>
          <p:blipFill>
            <a:blip r:embed="rId3"/>
            <a:stretch/>
          </p:blipFill>
          <p:spPr>
            <a:xfrm>
              <a:off x="4245120" y="587880"/>
              <a:ext cx="1439640" cy="1508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2" name="Grafik 6" descr="EYFP grün.jpg"/>
            <p:cNvPicPr/>
            <p:nvPr/>
          </p:nvPicPr>
          <p:blipFill>
            <a:blip r:embed="rId4"/>
            <a:stretch/>
          </p:blipFill>
          <p:spPr>
            <a:xfrm>
              <a:off x="2735280" y="587880"/>
              <a:ext cx="1439640" cy="1508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3" name="Grafik 7" descr="EYFP rot.jpg"/>
            <p:cNvPicPr/>
            <p:nvPr/>
          </p:nvPicPr>
          <p:blipFill>
            <a:blip r:embed="rId5"/>
            <a:stretch/>
          </p:blipFill>
          <p:spPr>
            <a:xfrm>
              <a:off x="5753160" y="587880"/>
              <a:ext cx="1439640" cy="1508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4" name="Grafik 8" descr="R2wt blau.jpg"/>
            <p:cNvPicPr/>
            <p:nvPr/>
          </p:nvPicPr>
          <p:blipFill>
            <a:blip r:embed="rId6"/>
            <a:stretch/>
          </p:blipFill>
          <p:spPr>
            <a:xfrm>
              <a:off x="4245120" y="2144520"/>
              <a:ext cx="1439640" cy="1508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5" name="Grafik 9" descr="R2wt grün.jpg"/>
            <p:cNvPicPr/>
            <p:nvPr/>
          </p:nvPicPr>
          <p:blipFill>
            <a:blip r:embed="rId7"/>
            <a:stretch/>
          </p:blipFill>
          <p:spPr>
            <a:xfrm>
              <a:off x="2735280" y="2144520"/>
              <a:ext cx="1439640" cy="1508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6" name="Grafik 10" descr="R2wt rot.jpg"/>
            <p:cNvPicPr/>
            <p:nvPr/>
          </p:nvPicPr>
          <p:blipFill>
            <a:blip r:embed="rId8"/>
            <a:stretch/>
          </p:blipFill>
          <p:spPr>
            <a:xfrm>
              <a:off x="5753160" y="2144520"/>
              <a:ext cx="1439640" cy="1508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7" name="Grafik 11" descr="R2wt rot blau.jpg"/>
            <p:cNvPicPr/>
            <p:nvPr/>
          </p:nvPicPr>
          <p:blipFill>
            <a:blip r:embed="rId9"/>
            <a:stretch/>
          </p:blipFill>
          <p:spPr>
            <a:xfrm>
              <a:off x="7263360" y="2144520"/>
              <a:ext cx="1439640" cy="15084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8" name="Grafik 12" descr="R2wt rot blau grün.jpg"/>
            <p:cNvPicPr/>
            <p:nvPr/>
          </p:nvPicPr>
          <p:blipFill>
            <a:blip r:embed="rId10"/>
            <a:stretch/>
          </p:blipFill>
          <p:spPr>
            <a:xfrm>
              <a:off x="1227240" y="2144520"/>
              <a:ext cx="1439640" cy="150840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9" name="Textfeld 13"/>
            <p:cNvSpPr/>
            <p:nvPr/>
          </p:nvSpPr>
          <p:spPr>
            <a:xfrm>
              <a:off x="929160" y="0"/>
              <a:ext cx="7990920" cy="520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              </a:t>
              </a:r>
              <a:r>
                <a:rPr b="0" lang="en-GB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merge: </a:t>
              </a:r>
              <a:r>
                <a:rPr b="0" lang="en-GB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	</a:t>
              </a:r>
              <a:r>
                <a:rPr b="0" lang="en-GB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      </a:t>
              </a:r>
              <a:r>
                <a:rPr b="0" lang="en-GB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	</a:t>
              </a:r>
              <a:r>
                <a:rPr b="0" lang="en-GB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	</a:t>
              </a:r>
              <a:r>
                <a:rPr b="0" lang="en-GB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	</a:t>
              </a:r>
              <a:r>
                <a:rPr b="0" lang="en-GB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	</a:t>
              </a:r>
              <a:r>
                <a:rPr b="0" lang="en-GB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	</a:t>
              </a:r>
              <a:r>
                <a:rPr b="0" lang="en-GB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     merge: 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yellow+DAPI +TUNEL</a:t>
              </a:r>
              <a:r>
                <a:rPr b="0" lang="en-GB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	</a:t>
              </a:r>
              <a:r>
                <a:rPr b="0" lang="en-GB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      yellow</a:t>
              </a:r>
              <a:r>
                <a:rPr b="0" lang="en-GB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	</a:t>
              </a:r>
              <a:r>
                <a:rPr b="0" lang="en-GB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                   DAPI</a:t>
              </a:r>
              <a:r>
                <a:rPr b="0" lang="en-GB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	</a:t>
              </a:r>
              <a:r>
                <a:rPr b="0" lang="en-GB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            TUNEL              DAPI+TUNEL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Textfeld 14"/>
            <p:cNvSpPr/>
            <p:nvPr/>
          </p:nvSpPr>
          <p:spPr>
            <a:xfrm>
              <a:off x="174600" y="1010160"/>
              <a:ext cx="1599840" cy="39301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EYFP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RASSF2wt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-EYFP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RASSF2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ΔSARAH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GB" sz="1400" spc="-1" strike="noStrike">
                  <a:solidFill>
                    <a:srgbClr val="000000"/>
                  </a:solidFill>
                  <a:latin typeface="Arial"/>
                  <a:ea typeface="Arial"/>
                </a:rPr>
                <a:t>-EYFP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pic>
          <p:nvPicPr>
            <p:cNvPr id="61" name="Grafik 16" descr="blau.jpg"/>
            <p:cNvPicPr/>
            <p:nvPr/>
          </p:nvPicPr>
          <p:blipFill>
            <a:blip r:embed="rId11"/>
            <a:stretch/>
          </p:blipFill>
          <p:spPr>
            <a:xfrm>
              <a:off x="4245120" y="3711600"/>
              <a:ext cx="1439280" cy="15098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2" name="Grafik 17" descr="grün.jpg"/>
            <p:cNvPicPr/>
            <p:nvPr/>
          </p:nvPicPr>
          <p:blipFill>
            <a:blip r:embed="rId12"/>
            <a:stretch/>
          </p:blipFill>
          <p:spPr>
            <a:xfrm>
              <a:off x="2735640" y="3711600"/>
              <a:ext cx="1439280" cy="15098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3" name="Grafik 18" descr="rot.jpg"/>
            <p:cNvPicPr/>
            <p:nvPr/>
          </p:nvPicPr>
          <p:blipFill>
            <a:blip r:embed="rId13"/>
            <a:stretch/>
          </p:blipFill>
          <p:spPr>
            <a:xfrm>
              <a:off x="5753520" y="3711600"/>
              <a:ext cx="1439280" cy="15098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4" name="Grafik 19" descr="rot blau.jpg"/>
            <p:cNvPicPr/>
            <p:nvPr/>
          </p:nvPicPr>
          <p:blipFill>
            <a:blip r:embed="rId14"/>
            <a:stretch/>
          </p:blipFill>
          <p:spPr>
            <a:xfrm>
              <a:off x="7263360" y="3711600"/>
              <a:ext cx="1439280" cy="15098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65" name="Grafik 20" descr="rot blau grün.jpg"/>
            <p:cNvPicPr/>
            <p:nvPr/>
          </p:nvPicPr>
          <p:blipFill>
            <a:blip r:embed="rId15"/>
            <a:stretch/>
          </p:blipFill>
          <p:spPr>
            <a:xfrm>
              <a:off x="1227240" y="3711600"/>
              <a:ext cx="1439280" cy="1509840"/>
            </a:xfrm>
            <a:prstGeom prst="rect">
              <a:avLst/>
            </a:prstGeom>
            <a:ln w="0">
              <a:noFill/>
            </a:ln>
          </p:spPr>
        </p:pic>
      </p:grpSp>
      <p:sp>
        <p:nvSpPr>
          <p:cNvPr id="66" name="Rectangle 22"/>
          <p:cNvSpPr/>
          <p:nvPr/>
        </p:nvSpPr>
        <p:spPr>
          <a:xfrm>
            <a:off x="120600" y="5429160"/>
            <a:ext cx="8915400" cy="10674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just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600" spc="-1" strike="noStrike">
                <a:solidFill>
                  <a:srgbClr val="000000"/>
                </a:solidFill>
                <a:latin typeface="Arial"/>
                <a:ea typeface="Arial"/>
              </a:rPr>
              <a:t>Additional file 4. </a:t>
            </a:r>
            <a:r>
              <a:rPr b="0" lang="en-GB" sz="1600" spc="-1" strike="noStrike">
                <a:solidFill>
                  <a:srgbClr val="000000"/>
                </a:solidFill>
                <a:latin typeface="Arial"/>
                <a:ea typeface="Arial"/>
              </a:rPr>
              <a:t>RASSF2 induced apoptosis. FTC133 cells were transfected with EYFP, RASSF2wt-EYFP and RASSF2ΔSARAH-EYFP.  After four days cells were fixed, </a:t>
            </a:r>
            <a:r>
              <a:rPr b="0" lang="en-GB" sz="1600" spc="-1" strike="noStrike">
                <a:solidFill>
                  <a:srgbClr val="000000"/>
                </a:solidFill>
                <a:latin typeface="Arial"/>
                <a:ea typeface="Arial"/>
              </a:rPr>
              <a:t>stained with TUNEL and DAPI. </a:t>
            </a:r>
            <a:r>
              <a:rPr b="0" lang="en-GB" sz="1600" spc="-1" strike="noStrike">
                <a:solidFill>
                  <a:srgbClr val="000000"/>
                </a:solidFill>
                <a:latin typeface="Arial"/>
                <a:ea typeface="Arial"/>
              </a:rPr>
              <a:t>Yellow fluorescence is shown in green. Apoptotic cells were analyzed by nuclear fragmentation and TUNEL assay.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3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0-09-14T07:09:46Z</dcterms:created>
  <dc:creator>Antje Maria</dc:creator>
  <dc:description/>
  <dc:language>en-US</dc:language>
  <cp:lastModifiedBy>Reinhard Dammann</cp:lastModifiedBy>
  <cp:lastPrinted>2010-07-16T11:37:46Z</cp:lastPrinted>
  <dcterms:modified xsi:type="dcterms:W3CDTF">2010-09-24T15:51:46Z</dcterms:modified>
  <cp:revision>13</cp:revision>
  <dc:subject/>
  <dc:title>Folie 1</dc:title>
</cp:coreProperties>
</file>